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4"/>
  </p:sldMasterIdLst>
  <p:notesMasterIdLst>
    <p:notesMasterId r:id="rId6"/>
  </p:notesMasterIdLst>
  <p:handoutMasterIdLst>
    <p:handoutMasterId r:id="rId7"/>
  </p:handoutMasterIdLst>
  <p:sldIdLst>
    <p:sldId id="266" r:id="rId5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Turnbull, Colin G N" initials="TCGN" lastIdx="6" clrIdx="0">
    <p:extLst>
      <p:ext uri="{19B8F6BF-5375-455C-9EA6-DF929625EA0E}">
        <p15:presenceInfo xmlns:p15="http://schemas.microsoft.com/office/powerpoint/2012/main" userId="S::ses00ct@ic.ac.uk::b0936a8f-839e-4b64-8c73-2cff8cb97d07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94"/>
  </p:normalViewPr>
  <p:slideViewPr>
    <p:cSldViewPr snapToGrid="0" snapToObjects="1">
      <p:cViewPr varScale="1">
        <p:scale>
          <a:sx n="155" d="100"/>
          <a:sy n="155" d="100"/>
        </p:scale>
        <p:origin x="1974" y="13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ommentAuthors" Target="commentAuthors.xml"/><Relationship Id="rId13" Type="http://schemas.microsoft.com/office/2016/11/relationships/changesInfo" Target="changesInfos/changesInfo1.xml"/><Relationship Id="rId3" Type="http://schemas.openxmlformats.org/officeDocument/2006/relationships/customXml" Target="../customXml/item3.xml"/><Relationship Id="rId7" Type="http://schemas.openxmlformats.org/officeDocument/2006/relationships/handoutMaster" Target="handoutMasters/handoutMaster1.xml"/><Relationship Id="rId12" Type="http://schemas.openxmlformats.org/officeDocument/2006/relationships/tableStyles" Target="tableStyle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openxmlformats.org/officeDocument/2006/relationships/theme" Target="theme/theme1.xml"/><Relationship Id="rId5" Type="http://schemas.openxmlformats.org/officeDocument/2006/relationships/slide" Target="slides/slide1.xml"/><Relationship Id="rId10" Type="http://schemas.openxmlformats.org/officeDocument/2006/relationships/viewProps" Target="viewProps.xml"/><Relationship Id="rId4" Type="http://schemas.openxmlformats.org/officeDocument/2006/relationships/slideMaster" Target="slideMasters/slideMaster1.xml"/><Relationship Id="rId9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Turnbull, Colin G N" userId="b0936a8f-839e-4b64-8c73-2cff8cb97d07" providerId="ADAL" clId="{DA9ADEEB-7557-4863-9CB3-1803173A95ED}"/>
    <pc:docChg chg="modSld">
      <pc:chgData name="Turnbull, Colin G N" userId="b0936a8f-839e-4b64-8c73-2cff8cb97d07" providerId="ADAL" clId="{DA9ADEEB-7557-4863-9CB3-1803173A95ED}" dt="2024-07-22T17:20:05.096" v="71" actId="20577"/>
      <pc:docMkLst>
        <pc:docMk/>
      </pc:docMkLst>
      <pc:sldChg chg="modSp mod">
        <pc:chgData name="Turnbull, Colin G N" userId="b0936a8f-839e-4b64-8c73-2cff8cb97d07" providerId="ADAL" clId="{DA9ADEEB-7557-4863-9CB3-1803173A95ED}" dt="2024-07-22T17:20:05.096" v="71" actId="20577"/>
        <pc:sldMkLst>
          <pc:docMk/>
          <pc:sldMk cId="3948929244" sldId="266"/>
        </pc:sldMkLst>
        <pc:spChg chg="mod">
          <ac:chgData name="Turnbull, Colin G N" userId="b0936a8f-839e-4b64-8c73-2cff8cb97d07" providerId="ADAL" clId="{DA9ADEEB-7557-4863-9CB3-1803173A95ED}" dt="2024-07-22T17:20:05.096" v="71" actId="20577"/>
          <ac:spMkLst>
            <pc:docMk/>
            <pc:sldMk cId="3948929244" sldId="266"/>
            <ac:spMk id="12" creationId="{297EE610-95E3-457A-B54C-DE90F845A1F0}"/>
          </ac:spMkLst>
        </pc:spChg>
      </pc:sldChg>
    </pc:docChg>
  </pc:docChgLst>
  <pc:docChgLst>
    <pc:chgData name="Turnbull, Colin G N" userId="b0936a8f-839e-4b64-8c73-2cff8cb97d07" providerId="ADAL" clId="{399D8325-AF2F-41C1-921C-87B96B8FEA20}"/>
    <pc:docChg chg="custSel addSld delSld modSld">
      <pc:chgData name="Turnbull, Colin G N" userId="b0936a8f-839e-4b64-8c73-2cff8cb97d07" providerId="ADAL" clId="{399D8325-AF2F-41C1-921C-87B96B8FEA20}" dt="2023-10-03T08:28:59.726" v="92" actId="47"/>
      <pc:docMkLst>
        <pc:docMk/>
      </pc:docMkLst>
      <pc:sldChg chg="del">
        <pc:chgData name="Turnbull, Colin G N" userId="b0936a8f-839e-4b64-8c73-2cff8cb97d07" providerId="ADAL" clId="{399D8325-AF2F-41C1-921C-87B96B8FEA20}" dt="2023-10-03T07:52:52.545" v="10" actId="47"/>
        <pc:sldMkLst>
          <pc:docMk/>
          <pc:sldMk cId="3948434701" sldId="257"/>
        </pc:sldMkLst>
      </pc:sldChg>
      <pc:sldChg chg="del">
        <pc:chgData name="Turnbull, Colin G N" userId="b0936a8f-839e-4b64-8c73-2cff8cb97d07" providerId="ADAL" clId="{399D8325-AF2F-41C1-921C-87B96B8FEA20}" dt="2023-10-03T07:53:01.220" v="11" actId="47"/>
        <pc:sldMkLst>
          <pc:docMk/>
          <pc:sldMk cId="17689549" sldId="258"/>
        </pc:sldMkLst>
      </pc:sldChg>
      <pc:sldChg chg="del">
        <pc:chgData name="Turnbull, Colin G N" userId="b0936a8f-839e-4b64-8c73-2cff8cb97d07" providerId="ADAL" clId="{399D8325-AF2F-41C1-921C-87B96B8FEA20}" dt="2023-10-03T07:53:01.220" v="11" actId="47"/>
        <pc:sldMkLst>
          <pc:docMk/>
          <pc:sldMk cId="517529597" sldId="259"/>
        </pc:sldMkLst>
      </pc:sldChg>
      <pc:sldChg chg="del">
        <pc:chgData name="Turnbull, Colin G N" userId="b0936a8f-839e-4b64-8c73-2cff8cb97d07" providerId="ADAL" clId="{399D8325-AF2F-41C1-921C-87B96B8FEA20}" dt="2023-10-03T07:53:01.220" v="11" actId="47"/>
        <pc:sldMkLst>
          <pc:docMk/>
          <pc:sldMk cId="1206776287" sldId="260"/>
        </pc:sldMkLst>
      </pc:sldChg>
      <pc:sldChg chg="del">
        <pc:chgData name="Turnbull, Colin G N" userId="b0936a8f-839e-4b64-8c73-2cff8cb97d07" providerId="ADAL" clId="{399D8325-AF2F-41C1-921C-87B96B8FEA20}" dt="2023-10-03T07:53:01.220" v="11" actId="47"/>
        <pc:sldMkLst>
          <pc:docMk/>
          <pc:sldMk cId="1981043606" sldId="261"/>
        </pc:sldMkLst>
      </pc:sldChg>
      <pc:sldChg chg="del">
        <pc:chgData name="Turnbull, Colin G N" userId="b0936a8f-839e-4b64-8c73-2cff8cb97d07" providerId="ADAL" clId="{399D8325-AF2F-41C1-921C-87B96B8FEA20}" dt="2023-10-03T07:53:01.220" v="11" actId="47"/>
        <pc:sldMkLst>
          <pc:docMk/>
          <pc:sldMk cId="4084646035" sldId="262"/>
        </pc:sldMkLst>
      </pc:sldChg>
      <pc:sldChg chg="del">
        <pc:chgData name="Turnbull, Colin G N" userId="b0936a8f-839e-4b64-8c73-2cff8cb97d07" providerId="ADAL" clId="{399D8325-AF2F-41C1-921C-87B96B8FEA20}" dt="2023-10-03T07:53:01.220" v="11" actId="47"/>
        <pc:sldMkLst>
          <pc:docMk/>
          <pc:sldMk cId="866988246" sldId="263"/>
        </pc:sldMkLst>
      </pc:sldChg>
      <pc:sldChg chg="addSp delSp modSp del mod">
        <pc:chgData name="Turnbull, Colin G N" userId="b0936a8f-839e-4b64-8c73-2cff8cb97d07" providerId="ADAL" clId="{399D8325-AF2F-41C1-921C-87B96B8FEA20}" dt="2023-10-03T08:28:59.726" v="92" actId="47"/>
        <pc:sldMkLst>
          <pc:docMk/>
          <pc:sldMk cId="2145446940" sldId="265"/>
        </pc:sldMkLst>
        <pc:spChg chg="del">
          <ac:chgData name="Turnbull, Colin G N" userId="b0936a8f-839e-4b64-8c73-2cff8cb97d07" providerId="ADAL" clId="{399D8325-AF2F-41C1-921C-87B96B8FEA20}" dt="2023-10-03T07:56:20.657" v="13" actId="478"/>
          <ac:spMkLst>
            <pc:docMk/>
            <pc:sldMk cId="2145446940" sldId="265"/>
            <ac:spMk id="2" creationId="{41CA8AAD-0961-481A-832A-E4DB94C0D5E7}"/>
          </ac:spMkLst>
        </pc:spChg>
        <pc:spChg chg="mod">
          <ac:chgData name="Turnbull, Colin G N" userId="b0936a8f-839e-4b64-8c73-2cff8cb97d07" providerId="ADAL" clId="{399D8325-AF2F-41C1-921C-87B96B8FEA20}" dt="2023-10-03T07:51:30.768" v="9" actId="20577"/>
          <ac:spMkLst>
            <pc:docMk/>
            <pc:sldMk cId="2145446940" sldId="265"/>
            <ac:spMk id="12" creationId="{297EE610-95E3-457A-B54C-DE90F845A1F0}"/>
          </ac:spMkLst>
        </pc:spChg>
        <pc:spChg chg="add del mod">
          <ac:chgData name="Turnbull, Colin G N" userId="b0936a8f-839e-4b64-8c73-2cff8cb97d07" providerId="ADAL" clId="{399D8325-AF2F-41C1-921C-87B96B8FEA20}" dt="2023-10-03T07:56:23.555" v="14" actId="478"/>
          <ac:spMkLst>
            <pc:docMk/>
            <pc:sldMk cId="2145446940" sldId="265"/>
            <ac:spMk id="13" creationId="{C2835E09-DDA1-EA5C-0259-F69DDEF59516}"/>
          </ac:spMkLst>
        </pc:spChg>
      </pc:sldChg>
      <pc:sldChg chg="del">
        <pc:chgData name="Turnbull, Colin G N" userId="b0936a8f-839e-4b64-8c73-2cff8cb97d07" providerId="ADAL" clId="{399D8325-AF2F-41C1-921C-87B96B8FEA20}" dt="2023-10-03T07:53:05.956" v="12" actId="47"/>
        <pc:sldMkLst>
          <pc:docMk/>
          <pc:sldMk cId="2696181814" sldId="266"/>
        </pc:sldMkLst>
      </pc:sldChg>
      <pc:sldChg chg="delSp modSp add mod">
        <pc:chgData name="Turnbull, Colin G N" userId="b0936a8f-839e-4b64-8c73-2cff8cb97d07" providerId="ADAL" clId="{399D8325-AF2F-41C1-921C-87B96B8FEA20}" dt="2023-10-03T08:27:47.175" v="91" actId="1037"/>
        <pc:sldMkLst>
          <pc:docMk/>
          <pc:sldMk cId="3948929244" sldId="266"/>
        </pc:sldMkLst>
        <pc:spChg chg="mod">
          <ac:chgData name="Turnbull, Colin G N" userId="b0936a8f-839e-4b64-8c73-2cff8cb97d07" providerId="ADAL" clId="{399D8325-AF2F-41C1-921C-87B96B8FEA20}" dt="2023-10-03T08:26:48.342" v="50" actId="1035"/>
          <ac:spMkLst>
            <pc:docMk/>
            <pc:sldMk cId="3948929244" sldId="266"/>
            <ac:spMk id="10" creationId="{D1AE3F27-1BD8-4C96-ADC0-181E189C10DA}"/>
          </ac:spMkLst>
        </pc:spChg>
        <pc:picChg chg="del mod">
          <ac:chgData name="Turnbull, Colin G N" userId="b0936a8f-839e-4b64-8c73-2cff8cb97d07" providerId="ADAL" clId="{399D8325-AF2F-41C1-921C-87B96B8FEA20}" dt="2023-10-03T08:25:21.251" v="27" actId="478"/>
          <ac:picMkLst>
            <pc:docMk/>
            <pc:sldMk cId="3948929244" sldId="266"/>
            <ac:picMk id="2" creationId="{D3A4F13A-7CBE-0D6D-017B-F3B5C8FF4438}"/>
          </ac:picMkLst>
        </pc:picChg>
        <pc:picChg chg="mod">
          <ac:chgData name="Turnbull, Colin G N" userId="b0936a8f-839e-4b64-8c73-2cff8cb97d07" providerId="ADAL" clId="{399D8325-AF2F-41C1-921C-87B96B8FEA20}" dt="2023-10-03T08:27:26.220" v="73" actId="1036"/>
          <ac:picMkLst>
            <pc:docMk/>
            <pc:sldMk cId="3948929244" sldId="266"/>
            <ac:picMk id="3" creationId="{ACFCA544-E897-FB6C-5687-D50E45E32165}"/>
          </ac:picMkLst>
        </pc:picChg>
        <pc:picChg chg="del">
          <ac:chgData name="Turnbull, Colin G N" userId="b0936a8f-839e-4b64-8c73-2cff8cb97d07" providerId="ADAL" clId="{399D8325-AF2F-41C1-921C-87B96B8FEA20}" dt="2023-10-03T08:23:49.235" v="21" actId="478"/>
          <ac:picMkLst>
            <pc:docMk/>
            <pc:sldMk cId="3948929244" sldId="266"/>
            <ac:picMk id="6" creationId="{F557A1D3-19BB-4A26-BA61-0222CA6A1D58}"/>
          </ac:picMkLst>
        </pc:picChg>
        <pc:picChg chg="del">
          <ac:chgData name="Turnbull, Colin G N" userId="b0936a8f-839e-4b64-8c73-2cff8cb97d07" providerId="ADAL" clId="{399D8325-AF2F-41C1-921C-87B96B8FEA20}" dt="2023-10-03T08:23:51.235" v="22" actId="478"/>
          <ac:picMkLst>
            <pc:docMk/>
            <pc:sldMk cId="3948929244" sldId="266"/>
            <ac:picMk id="7" creationId="{C33C1187-0040-43DD-A546-6D7348F99D8A}"/>
          </ac:picMkLst>
        </pc:picChg>
        <pc:picChg chg="del">
          <ac:chgData name="Turnbull, Colin G N" userId="b0936a8f-839e-4b64-8c73-2cff8cb97d07" providerId="ADAL" clId="{399D8325-AF2F-41C1-921C-87B96B8FEA20}" dt="2023-10-03T08:23:53.282" v="23" actId="478"/>
          <ac:picMkLst>
            <pc:docMk/>
            <pc:sldMk cId="3948929244" sldId="266"/>
            <ac:picMk id="8" creationId="{66C80566-CAB2-4F84-B1D8-E7358EBFF029}"/>
          </ac:picMkLst>
        </pc:picChg>
        <pc:picChg chg="mod">
          <ac:chgData name="Turnbull, Colin G N" userId="b0936a8f-839e-4b64-8c73-2cff8cb97d07" providerId="ADAL" clId="{399D8325-AF2F-41C1-921C-87B96B8FEA20}" dt="2023-10-03T08:27:47.175" v="91" actId="1037"/>
          <ac:picMkLst>
            <pc:docMk/>
            <pc:sldMk cId="3948929244" sldId="266"/>
            <ac:picMk id="13" creationId="{33D98801-FBD8-D917-B6B1-548EAE62AEE7}"/>
          </ac:picMkLst>
        </pc:picChg>
        <pc:picChg chg="mod">
          <ac:chgData name="Turnbull, Colin G N" userId="b0936a8f-839e-4b64-8c73-2cff8cb97d07" providerId="ADAL" clId="{399D8325-AF2F-41C1-921C-87B96B8FEA20}" dt="2023-10-03T08:27:36.021" v="76" actId="1038"/>
          <ac:picMkLst>
            <pc:docMk/>
            <pc:sldMk cId="3948929244" sldId="266"/>
            <ac:picMk id="14" creationId="{444564D7-1568-B758-4422-913F4ADA20CE}"/>
          </ac:picMkLst>
        </pc:picChg>
      </pc:sldChg>
    </pc:docChg>
  </pc:docChgLst>
</pc:chgInfo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C3A113C-1C47-844F-B75F-5173A85BAE7C}" type="datetimeFigureOut">
              <a:rPr lang="en-US" smtClean="0"/>
              <a:t>7/19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C5D90E9-5FDA-9B4D-860D-8F36E6A954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3924500"/>
      </p:ext>
    </p:extLst>
  </p:cSld>
  <p:clrMap bg1="lt1" tx1="dk1" bg2="lt2" tx2="dk2" accent1="accent1" accent2="accent2" accent3="accent3" accent4="accent4" accent5="accent5" accent6="accent6" hlink="hlink" folHlink="folHlink"/>
  <p:hf hdr="0" ftr="0" dt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2BAAE53-D4A2-7F47-BB49-5A075B857ED8}" type="datetimeFigureOut">
              <a:rPr lang="en-US" smtClean="0"/>
              <a:t>7/19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F2FBE6D-2991-C449-82CB-0CFD60385A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8403306"/>
      </p:ext>
    </p:extLst>
  </p:cSld>
  <p:clrMap bg1="lt1" tx1="dk1" bg2="lt2" tx2="dk2" accent1="accent1" accent2="accent2" accent3="accent3" accent4="accent4" accent5="accent5" accent6="accent6" hlink="hlink" folHlink="folHlink"/>
  <p:hf hdr="0" ftr="0" dt="0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61D3D-EB70-C44B-BE81-6DFEC21C4DD9}" type="datetime1">
              <a:rPr lang="en-GB" smtClean="0"/>
              <a:t>19/0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99401C-CD7C-3044-81DD-B2A1E77C82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30688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AC09C8-F94C-EE47-939D-BFE99CF31635}" type="datetime1">
              <a:rPr lang="en-GB" smtClean="0"/>
              <a:t>19/0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99401C-CD7C-3044-81DD-B2A1E77C82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67296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54A895-8897-BE47-BFFE-4AB29F9B508E}" type="datetime1">
              <a:rPr lang="en-GB" smtClean="0"/>
              <a:t>19/0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99401C-CD7C-3044-81DD-B2A1E77C82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97196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6CCD12-4408-5F44-AA94-5E685EC53467}" type="datetime1">
              <a:rPr lang="en-GB" smtClean="0"/>
              <a:t>19/0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99401C-CD7C-3044-81DD-B2A1E77C82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63061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713247-1C4F-4D48-903C-2BD0FE00ABD6}" type="datetime1">
              <a:rPr lang="en-GB" smtClean="0"/>
              <a:t>19/0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99401C-CD7C-3044-81DD-B2A1E77C82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21290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61DBA4-EE2A-D743-B2F8-9637F87C8818}" type="datetime1">
              <a:rPr lang="en-GB" smtClean="0"/>
              <a:t>19/07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99401C-CD7C-3044-81DD-B2A1E77C82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95756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31AC0C-100D-FC4F-9321-B6A1D9AC4908}" type="datetime1">
              <a:rPr lang="en-GB" smtClean="0"/>
              <a:t>19/07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99401C-CD7C-3044-81DD-B2A1E77C82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28159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6DB066-FD28-5741-82BB-604DF8424C17}" type="datetime1">
              <a:rPr lang="en-GB" smtClean="0"/>
              <a:t>19/07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99401C-CD7C-3044-81DD-B2A1E77C82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53152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2BEBF9-7724-1545-973C-A61A57EDF7E9}" type="datetime1">
              <a:rPr lang="en-GB" smtClean="0"/>
              <a:t>19/07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99401C-CD7C-3044-81DD-B2A1E77C82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3363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3021B1-29B1-7941-A296-FEDD060992E3}" type="datetime1">
              <a:rPr lang="en-GB" smtClean="0"/>
              <a:t>19/07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99401C-CD7C-3044-81DD-B2A1E77C82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79099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EDA484-C9EA-214E-A818-7CD3903908E2}" type="datetime1">
              <a:rPr lang="en-GB" smtClean="0"/>
              <a:t>19/07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99401C-CD7C-3044-81DD-B2A1E77C82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03573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FD0633-D5F9-0846-80ED-CB30D751B12C}" type="datetime1">
              <a:rPr lang="en-GB" smtClean="0"/>
              <a:t>19/0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99401C-CD7C-3044-81DD-B2A1E77C82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82857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ftr="0" dt="0"/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svg"/><Relationship Id="rId7" Type="http://schemas.openxmlformats.org/officeDocument/2006/relationships/image" Target="../media/image6.sv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5.png"/><Relationship Id="rId5" Type="http://schemas.openxmlformats.org/officeDocument/2006/relationships/image" Target="../media/image4.sv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708CAF8-57D5-4E59-BB42-C94E86891B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99401C-CD7C-3044-81DD-B2A1E77C8237}" type="slidenum">
              <a:rPr lang="en-US" smtClean="0"/>
              <a:t>1</a:t>
            </a:fld>
            <a:endParaRPr lang="en-US"/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04C7ADBE-269B-469E-A652-3D3274ACED6B}"/>
              </a:ext>
            </a:extLst>
          </p:cNvPr>
          <p:cNvGrpSpPr/>
          <p:nvPr/>
        </p:nvGrpSpPr>
        <p:grpSpPr>
          <a:xfrm>
            <a:off x="457200" y="708409"/>
            <a:ext cx="369115" cy="4364701"/>
            <a:chOff x="364576" y="2524740"/>
            <a:chExt cx="369115" cy="4364701"/>
          </a:xfrm>
        </p:grpSpPr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58207F15-4741-4BB2-9A8B-74CA5ED849BD}"/>
                </a:ext>
              </a:extLst>
            </p:cNvPr>
            <p:cNvSpPr txBox="1"/>
            <p:nvPr/>
          </p:nvSpPr>
          <p:spPr>
            <a:xfrm>
              <a:off x="364576" y="2524740"/>
              <a:ext cx="36911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/>
                <a:t>A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D1AE3F27-1BD8-4C96-ADC0-181E189C10DA}"/>
                </a:ext>
              </a:extLst>
            </p:cNvPr>
            <p:cNvSpPr txBox="1"/>
            <p:nvPr/>
          </p:nvSpPr>
          <p:spPr>
            <a:xfrm>
              <a:off x="364576" y="6520109"/>
              <a:ext cx="36911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 dirty="0"/>
                <a:t>C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27B0BF92-A7F2-40FC-8AAF-217D11D1361C}"/>
                </a:ext>
              </a:extLst>
            </p:cNvPr>
            <p:cNvSpPr txBox="1"/>
            <p:nvPr/>
          </p:nvSpPr>
          <p:spPr>
            <a:xfrm>
              <a:off x="364576" y="4486923"/>
              <a:ext cx="36911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/>
                <a:t>B</a:t>
              </a:r>
            </a:p>
          </p:txBody>
        </p:sp>
      </p:grpSp>
      <p:sp>
        <p:nvSpPr>
          <p:cNvPr id="12" name="Rectangle 11">
            <a:extLst>
              <a:ext uri="{FF2B5EF4-FFF2-40B4-BE49-F238E27FC236}">
                <a16:creationId xmlns:a16="http://schemas.microsoft.com/office/drawing/2014/main" id="{297EE610-95E3-457A-B54C-DE90F845A1F0}"/>
              </a:ext>
            </a:extLst>
          </p:cNvPr>
          <p:cNvSpPr/>
          <p:nvPr/>
        </p:nvSpPr>
        <p:spPr>
          <a:xfrm>
            <a:off x="4482037" y="4831881"/>
            <a:ext cx="4204763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b="1" dirty="0"/>
              <a:t>Supp. Figure 1. Virulence phenotypes of F1 populations from reciprocal crosses of PS01 and N116. </a:t>
            </a:r>
            <a:r>
              <a:rPr lang="en-GB" sz="1000" dirty="0"/>
              <a:t>NP clones are N116 female x PS01 male; PN clones are PS01 female x N116 male. A total of 78 clones were scored for survival and reproduction. </a:t>
            </a:r>
            <a:r>
              <a:rPr lang="en-GB" sz="1000" b="1" dirty="0"/>
              <a:t>A</a:t>
            </a:r>
            <a:r>
              <a:rPr lang="en-GB" sz="1000" dirty="0"/>
              <a:t>.  Performance on A17 and RNIL hosts. Clone numbers prefaced by V or A were used for the virulent and avirulent pools for RNA-</a:t>
            </a:r>
            <a:r>
              <a:rPr lang="en-GB" sz="1000" dirty="0" err="1"/>
              <a:t>Seq</a:t>
            </a:r>
            <a:r>
              <a:rPr lang="en-GB" sz="1000" dirty="0"/>
              <a:t>, respectively; </a:t>
            </a:r>
            <a:r>
              <a:rPr lang="en-GB" sz="1000" b="1" dirty="0"/>
              <a:t>B</a:t>
            </a:r>
            <a:r>
              <a:rPr lang="en-GB" sz="1000" dirty="0"/>
              <a:t>. Performance on DZA315.16 and SNIL hosts; </a:t>
            </a:r>
            <a:r>
              <a:rPr lang="en-GB" sz="1000" b="1" dirty="0"/>
              <a:t>C</a:t>
            </a:r>
            <a:r>
              <a:rPr lang="en-GB" sz="1000" dirty="0"/>
              <a:t>. Phenotype confirmation of clones selected for RNA-</a:t>
            </a:r>
            <a:r>
              <a:rPr lang="en-GB" sz="1000" dirty="0" err="1"/>
              <a:t>Seq</a:t>
            </a:r>
            <a:r>
              <a:rPr lang="en-GB" sz="1000" dirty="0"/>
              <a:t>, measured as mean survival after 5 d on A17 and RNIL hosts, with 5 aphids each on 4 plants of each host genotype. Dashed line divides virulent from avirulent clones.</a:t>
            </a:r>
          </a:p>
        </p:txBody>
      </p:sp>
      <p:pic>
        <p:nvPicPr>
          <p:cNvPr id="3" name="Graphic 2">
            <a:extLst>
              <a:ext uri="{FF2B5EF4-FFF2-40B4-BE49-F238E27FC236}">
                <a16:creationId xmlns:a16="http://schemas.microsoft.com/office/drawing/2014/main" id="{ACFCA544-E897-FB6C-5687-D50E45E3216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662077" y="2763480"/>
            <a:ext cx="5760000" cy="2001951"/>
          </a:xfrm>
          <a:prstGeom prst="rect">
            <a:avLst/>
          </a:prstGeom>
        </p:spPr>
      </p:pic>
      <p:pic>
        <p:nvPicPr>
          <p:cNvPr id="13" name="Graphic 12">
            <a:extLst>
              <a:ext uri="{FF2B5EF4-FFF2-40B4-BE49-F238E27FC236}">
                <a16:creationId xmlns:a16="http://schemas.microsoft.com/office/drawing/2014/main" id="{33D98801-FBD8-D917-B6B1-548EAE62AEE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764947" y="4698187"/>
            <a:ext cx="3600000" cy="1891525"/>
          </a:xfrm>
          <a:prstGeom prst="rect">
            <a:avLst/>
          </a:prstGeom>
        </p:spPr>
      </p:pic>
      <p:pic>
        <p:nvPicPr>
          <p:cNvPr id="14" name="Graphic 13">
            <a:extLst>
              <a:ext uri="{FF2B5EF4-FFF2-40B4-BE49-F238E27FC236}">
                <a16:creationId xmlns:a16="http://schemas.microsoft.com/office/drawing/2014/main" id="{444564D7-1568-B758-4422-913F4ADA20CE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96DAC541-7B7A-43D3-8B79-37D633B846F1}">
                <asvg:svgBlip xmlns:asvg="http://schemas.microsoft.com/office/drawing/2016/SVG/main" r:embed="rId7"/>
              </a:ext>
            </a:extLst>
          </a:blip>
          <a:stretch>
            <a:fillRect/>
          </a:stretch>
        </p:blipFill>
        <p:spPr>
          <a:xfrm>
            <a:off x="696367" y="800092"/>
            <a:ext cx="5760000" cy="201635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489292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f86f7079-b6d0-498a-af8d-579bcdeb03e2">
      <Terms xmlns="http://schemas.microsoft.com/office/infopath/2007/PartnerControls"/>
    </lcf76f155ced4ddcb4097134ff3c332f>
    <TaxCatchAll xmlns="bfb7cb04-722f-4bf5-a909-aaa84edbd72b" xsi:nil="true"/>
  </documentManagement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CD3E030CC3304D4FAA1494568698B22B" ma:contentTypeVersion="13" ma:contentTypeDescription="Create a new document." ma:contentTypeScope="" ma:versionID="320a3cc587b0b8798ec87d2c9ae13a4b">
  <xsd:schema xmlns:xsd="http://www.w3.org/2001/XMLSchema" xmlns:xs="http://www.w3.org/2001/XMLSchema" xmlns:p="http://schemas.microsoft.com/office/2006/metadata/properties" xmlns:ns2="f86f7079-b6d0-498a-af8d-579bcdeb03e2" xmlns:ns3="bfb7cb04-722f-4bf5-a909-aaa84edbd72b" targetNamespace="http://schemas.microsoft.com/office/2006/metadata/properties" ma:root="true" ma:fieldsID="a8591c90f32f289a4b8174ae50a1ec0d" ns2:_="" ns3:_="">
    <xsd:import namespace="f86f7079-b6d0-498a-af8d-579bcdeb03e2"/>
    <xsd:import namespace="bfb7cb04-722f-4bf5-a909-aaa84edbd72b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2:MediaServiceObjectDetectorVersions" minOccurs="0"/>
                <xsd:element ref="ns2:MediaServiceSearchProperties" minOccurs="0"/>
                <xsd:element ref="ns2:lcf76f155ced4ddcb4097134ff3c332f" minOccurs="0"/>
                <xsd:element ref="ns3:TaxCatchAll" minOccurs="0"/>
                <xsd:element ref="ns2:MediaServiceDateTaken" minOccurs="0"/>
                <xsd:element ref="ns2:MediaServiceOCR" minOccurs="0"/>
                <xsd:element ref="ns2:MediaServiceGenerationTime" minOccurs="0"/>
                <xsd:element ref="ns2:MediaServiceEventHashCode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f86f7079-b6d0-498a-af8d-579bcdeb03e2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ObjectDetectorVersions" ma:index="12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13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lcf76f155ced4ddcb4097134ff3c332f" ma:index="15" nillable="true" ma:taxonomy="true" ma:internalName="lcf76f155ced4ddcb4097134ff3c332f" ma:taxonomyFieldName="MediaServiceImageTags" ma:displayName="Image Tags" ma:readOnly="false" ma:fieldId="{5cf76f15-5ced-4ddc-b409-7134ff3c332f}" ma:taxonomyMulti="true" ma:sspId="74661dae-d6df-48fc-a54e-a577d2899e9c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DateTaken" ma:index="17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ServiceOCR" ma:index="18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9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20" nillable="true" ma:displayName="MediaServiceEventHashCode" ma:hidden="true" ma:internalName="MediaServiceEventHashCode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bfb7cb04-722f-4bf5-a909-aaa84edbd72b" elementFormDefault="qualified">
    <xsd:import namespace="http://schemas.microsoft.com/office/2006/documentManagement/types"/>
    <xsd:import namespace="http://schemas.microsoft.com/office/infopath/2007/PartnerControls"/>
    <xsd:element name="TaxCatchAll" ma:index="16" nillable="true" ma:displayName="Taxonomy Catch All Column" ma:hidden="true" ma:list="{dcd4b33b-65a2-4237-a489-b47d393d9200}" ma:internalName="TaxCatchAll" ma:showField="CatchAllData" ma:web="bfb7cb04-722f-4bf5-a909-aaa84edbd72b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CCBF2603-E248-4380-AF0F-64411E0524B4}">
  <ds:schemaRefs>
    <ds:schemaRef ds:uri="http://purl.org/dc/terms/"/>
    <ds:schemaRef ds:uri="http://schemas.openxmlformats.org/package/2006/metadata/core-properties"/>
    <ds:schemaRef ds:uri="http://schemas.microsoft.com/office/2006/documentManagement/types"/>
    <ds:schemaRef ds:uri="http://schemas.microsoft.com/office/infopath/2007/PartnerControls"/>
    <ds:schemaRef ds:uri="http://purl.org/dc/elements/1.1/"/>
    <ds:schemaRef ds:uri="http://schemas.microsoft.com/office/2006/metadata/properties"/>
    <ds:schemaRef ds:uri="f86f7079-b6d0-498a-af8d-579bcdeb03e2"/>
    <ds:schemaRef ds:uri="http://www.w3.org/XML/1998/namespace"/>
    <ds:schemaRef ds:uri="http://purl.org/dc/dcmitype/"/>
    <ds:schemaRef ds:uri="bfb7cb04-722f-4bf5-a909-aaa84edbd72b"/>
  </ds:schemaRefs>
</ds:datastoreItem>
</file>

<file path=customXml/itemProps2.xml><?xml version="1.0" encoding="utf-8"?>
<ds:datastoreItem xmlns:ds="http://schemas.openxmlformats.org/officeDocument/2006/customXml" ds:itemID="{626A8F7C-C007-4FE2-859C-E721B7C35B0B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9530AD5C-D1E1-4FCC-BE70-998D89BFB3A8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f86f7079-b6d0-498a-af8d-579bcdeb03e2"/>
    <ds:schemaRef ds:uri="bfb7cb04-722f-4bf5-a909-aaa84edbd72b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5348</TotalTime>
  <Words>133</Words>
  <Application>Microsoft Office PowerPoint</Application>
  <PresentationFormat>On-screen Show (4:3)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SCRI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runn Bos</dc:creator>
  <cp:lastModifiedBy>Turnbull, Colin </cp:lastModifiedBy>
  <cp:revision>31</cp:revision>
  <dcterms:created xsi:type="dcterms:W3CDTF">2020-10-26T15:15:52Z</dcterms:created>
  <dcterms:modified xsi:type="dcterms:W3CDTF">2024-07-22T17:20:0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CD3E030CC3304D4FAA1494568698B22B</vt:lpwstr>
  </property>
  <property fmtid="{D5CDD505-2E9C-101B-9397-08002B2CF9AE}" pid="3" name="MediaServiceImageTags">
    <vt:lpwstr/>
  </property>
</Properties>
</file>